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6858000" cy="12192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06" userDrawn="1">
          <p15:clr>
            <a:srgbClr val="A4A3A4"/>
          </p15:clr>
        </p15:guide>
        <p15:guide id="2" pos="45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 showGuides="1">
      <p:cViewPr varScale="1">
        <p:scale>
          <a:sx n="48" d="100"/>
          <a:sy n="48" d="100"/>
        </p:scale>
        <p:origin x="2755" y="53"/>
      </p:cViewPr>
      <p:guideLst>
        <p:guide orient="horz" pos="2706"/>
        <p:guide pos="45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D:\Project_20181018%20backup\PGC-1a%20&amp;%20Fibrosis\real-time%20PCR\20190916\20190916\20190916%20UUO%207%20d%20and%2014dmCol1A1%20mCol3A1%20mGAPDH_data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D:\Project_20181018%20backup\PGC-1a%20&amp;%20Fibrosis\real-time%20PCR\20190916\20190916\20190916%20UUO%207%20d%20and%2014dmCol1A1%20mCol3A1%20mGAPDH_data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nd-Bar'!$I$33</c:f>
              <c:strCache>
                <c:ptCount val="1"/>
                <c:pt idx="0">
                  <c:v>Col1a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nd-Bar'!$I$40:$I$43</c:f>
                <c:numCache>
                  <c:formatCode>General</c:formatCode>
                  <c:ptCount val="4"/>
                  <c:pt idx="0">
                    <c:v>0.15899711450948659</c:v>
                  </c:pt>
                  <c:pt idx="1">
                    <c:v>2.4150696833053864</c:v>
                  </c:pt>
                  <c:pt idx="2">
                    <c:v>0.15884753451641578</c:v>
                  </c:pt>
                  <c:pt idx="3">
                    <c:v>27.947007483768694</c:v>
                  </c:pt>
                </c:numCache>
              </c:numRef>
            </c:plus>
            <c:minus>
              <c:numRef>
                <c:f>'2nd-Bar'!$Q$36</c:f>
                <c:numCache>
                  <c:formatCode>General</c:formatCode>
                  <c:ptCount val="1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2nd-Bar'!$G$34:$H$37</c:f>
              <c:multiLvlStrCache>
                <c:ptCount val="4"/>
                <c:lvl>
                  <c:pt idx="0">
                    <c:v>Control</c:v>
                  </c:pt>
                  <c:pt idx="1">
                    <c:v>UUO</c:v>
                  </c:pt>
                  <c:pt idx="2">
                    <c:v>Control</c:v>
                  </c:pt>
                  <c:pt idx="3">
                    <c:v>UUO</c:v>
                  </c:pt>
                </c:lvl>
                <c:lvl>
                  <c:pt idx="0">
                    <c:v>Day 7</c:v>
                  </c:pt>
                  <c:pt idx="2">
                    <c:v>Day 14</c:v>
                  </c:pt>
                </c:lvl>
              </c:multiLvlStrCache>
            </c:multiLvlStrRef>
          </c:cat>
          <c:val>
            <c:numRef>
              <c:f>'2nd-Bar'!$I$34:$I$37</c:f>
              <c:numCache>
                <c:formatCode>General</c:formatCode>
                <c:ptCount val="4"/>
                <c:pt idx="0">
                  <c:v>1.0104131009144426</c:v>
                </c:pt>
                <c:pt idx="1">
                  <c:v>8.8648730495275458</c:v>
                </c:pt>
                <c:pt idx="2">
                  <c:v>1.0978662287175824</c:v>
                </c:pt>
                <c:pt idx="3">
                  <c:v>119.844744949723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D8-406C-B6CB-E1188FF460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2190991"/>
        <c:axId val="504795455"/>
      </c:barChart>
      <c:catAx>
        <c:axId val="582190991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504795455"/>
        <c:crosses val="autoZero"/>
        <c:auto val="1"/>
        <c:lblAlgn val="ctr"/>
        <c:lblOffset val="100"/>
        <c:noMultiLvlLbl val="0"/>
      </c:catAx>
      <c:valAx>
        <c:axId val="504795455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582190991"/>
        <c:crosses val="autoZero"/>
        <c:crossBetween val="between"/>
        <c:majorUnit val="4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nd-Bar'!$E$33</c:f>
              <c:strCache>
                <c:ptCount val="1"/>
                <c:pt idx="0">
                  <c:v>Col3a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nd-Bar'!$J$40:$J$43</c:f>
                <c:numCache>
                  <c:formatCode>General</c:formatCode>
                  <c:ptCount val="4"/>
                  <c:pt idx="0">
                    <c:v>0.326933531439773</c:v>
                  </c:pt>
                  <c:pt idx="1">
                    <c:v>7.817670861077727</c:v>
                  </c:pt>
                  <c:pt idx="2">
                    <c:v>0.33082394861928266</c:v>
                  </c:pt>
                  <c:pt idx="3">
                    <c:v>16.269411274433537</c:v>
                  </c:pt>
                </c:numCache>
              </c:numRef>
            </c:plus>
            <c:minus>
              <c:numRef>
                <c:f>'2nd-Bar'!$J$40:$J$43</c:f>
                <c:numCache>
                  <c:formatCode>General</c:formatCode>
                  <c:ptCount val="4"/>
                  <c:pt idx="0">
                    <c:v>0.326933531439773</c:v>
                  </c:pt>
                  <c:pt idx="1">
                    <c:v>7.817670861077727</c:v>
                  </c:pt>
                  <c:pt idx="2">
                    <c:v>0.33082394861928266</c:v>
                  </c:pt>
                  <c:pt idx="3">
                    <c:v>16.2694112744335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2nd-Bar'!$C$34:$D$37</c:f>
              <c:multiLvlStrCache>
                <c:ptCount val="4"/>
                <c:lvl>
                  <c:pt idx="0">
                    <c:v>Control</c:v>
                  </c:pt>
                  <c:pt idx="1">
                    <c:v>UUO</c:v>
                  </c:pt>
                  <c:pt idx="2">
                    <c:v>Control</c:v>
                  </c:pt>
                  <c:pt idx="3">
                    <c:v>UUO</c:v>
                  </c:pt>
                </c:lvl>
                <c:lvl>
                  <c:pt idx="0">
                    <c:v>Day 7</c:v>
                  </c:pt>
                  <c:pt idx="2">
                    <c:v>Day 14</c:v>
                  </c:pt>
                </c:lvl>
              </c:multiLvlStrCache>
            </c:multiLvlStrRef>
          </c:cat>
          <c:val>
            <c:numRef>
              <c:f>'2nd-Bar'!$E$34:$E$37</c:f>
              <c:numCache>
                <c:formatCode>General</c:formatCode>
                <c:ptCount val="4"/>
                <c:pt idx="0">
                  <c:v>1.0427805517170852</c:v>
                </c:pt>
                <c:pt idx="1">
                  <c:v>21.296688900591125</c:v>
                </c:pt>
                <c:pt idx="2">
                  <c:v>1.1872475015781061</c:v>
                </c:pt>
                <c:pt idx="3">
                  <c:v>72.0476470624805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6E0-4F30-889F-6339BBB833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6261199"/>
        <c:axId val="596256207"/>
      </c:barChart>
      <c:catAx>
        <c:axId val="596261199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596256207"/>
        <c:crosses val="autoZero"/>
        <c:auto val="1"/>
        <c:lblAlgn val="ctr"/>
        <c:lblOffset val="100"/>
        <c:noMultiLvlLbl val="0"/>
      </c:catAx>
      <c:valAx>
        <c:axId val="596256207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596261199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3891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504653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41139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530227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21964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06645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50939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36896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47351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74780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dirty="0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68476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609E2E-DA76-43D1-A62E-546695C4D425}" type="datetimeFigureOut">
              <a:rPr lang="ko-KR" altLang="en-US" smtClean="0"/>
              <a:t>2019-09-19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C13D4D-8160-414D-BEA0-F2F4B87485FF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783457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5272400"/>
              </p:ext>
            </p:extLst>
          </p:nvPr>
        </p:nvGraphicFramePr>
        <p:xfrm>
          <a:off x="946524" y="1288798"/>
          <a:ext cx="2438578" cy="20418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차트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6543921"/>
              </p:ext>
            </p:extLst>
          </p:nvPr>
        </p:nvGraphicFramePr>
        <p:xfrm>
          <a:off x="3549831" y="1275630"/>
          <a:ext cx="2390738" cy="20418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 rot="16200000">
            <a:off x="-12108" y="1943861"/>
            <a:ext cx="1799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l1a1/GAPDH (Fold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2598869" y="1943862"/>
            <a:ext cx="1799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l3a1/GAPDH (Fold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04525" y="3456776"/>
            <a:ext cx="5961153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he mRNA expression level of extracellular matrix proteins in UUO kidney. The level of Col1a1 (A) and Col3a1 (B)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nalyzed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by real-time PCR. bar graphs of mRNA levels show mean PGC-1α/GAPDH expression. </a:t>
            </a:r>
            <a:r>
              <a:rPr lang="en-US" altLang="ko-KR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altLang="ko-KR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&lt; 0.05,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UUO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kidney vs. control kidney. Primer sequences for real-time PCR were as follows: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Col1a1</a:t>
            </a:r>
            <a:r>
              <a:rPr lang="el-GR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forward, 5’-GAGCGGAGAGTACTGGATCG-3’, reverse, 5’- AGACGGCTGAGTAGGGAACA -3’; 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Col3a1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, forward, 5’-ACCAAAAGGTGATGCTGGAC-3’, reverse, 5’- GACCTCGTGCTCCAGTTAGC -3’; </a:t>
            </a:r>
            <a:r>
              <a:rPr lang="en-US" altLang="ko-KR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GAPDH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forward, 5’-TGTGTCCTCGTGGATCTGA-3’, reverse, 5’- GATGCCTGCTTCACCACCTT -3</a:t>
            </a:r>
            <a:r>
              <a:rPr lang="en-US" altLang="ko-KR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’.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91037" y="793291"/>
            <a:ext cx="355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152572" y="793291"/>
            <a:ext cx="355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직사각형 9"/>
          <p:cNvSpPr/>
          <p:nvPr/>
        </p:nvSpPr>
        <p:spPr>
          <a:xfrm flipH="1">
            <a:off x="1938925" y="2461594"/>
            <a:ext cx="27250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직사각형 10"/>
          <p:cNvSpPr/>
          <p:nvPr/>
        </p:nvSpPr>
        <p:spPr>
          <a:xfrm flipH="1">
            <a:off x="2880069" y="1301966"/>
            <a:ext cx="27250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직사각형 11"/>
          <p:cNvSpPr/>
          <p:nvPr/>
        </p:nvSpPr>
        <p:spPr>
          <a:xfrm flipH="1">
            <a:off x="4513567" y="2173420"/>
            <a:ext cx="27250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직사각형 12"/>
          <p:cNvSpPr/>
          <p:nvPr/>
        </p:nvSpPr>
        <p:spPr>
          <a:xfrm flipH="1">
            <a:off x="5446576" y="1372590"/>
            <a:ext cx="27250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69557" y="242226"/>
            <a:ext cx="30641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s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0451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47</TotalTime>
  <Words>128</Words>
  <Application>Microsoft Office PowerPoint</Application>
  <PresentationFormat>와이드스크린</PresentationFormat>
  <Paragraphs>1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Choi Hoon In</cp:lastModifiedBy>
  <cp:revision>141</cp:revision>
  <dcterms:created xsi:type="dcterms:W3CDTF">2018-11-26T01:10:51Z</dcterms:created>
  <dcterms:modified xsi:type="dcterms:W3CDTF">2019-09-19T02:59:58Z</dcterms:modified>
</cp:coreProperties>
</file>